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1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059"/>
    <p:restoredTop sz="94617"/>
  </p:normalViewPr>
  <p:slideViewPr>
    <p:cSldViewPr snapToGrid="0" snapToObjects="1">
      <p:cViewPr varScale="1">
        <p:scale>
          <a:sx n="46" d="100"/>
          <a:sy n="46" d="100"/>
        </p:scale>
        <p:origin x="176" y="1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D64E0-868F-124B-8687-9728DE0BAA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74A96F-862E-E441-9B68-16D21B8C27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7FC0D8-4429-3849-BFCE-3F7E98F6D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D981F-8500-4349-A526-94EA4541F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EBCD79-D864-5845-A6FA-3BE291FAF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272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D701E2-AC86-D442-867E-0432AF05B1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09D681-8A94-374A-9EA4-F7EBA14116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B1E8C1-F2A8-1943-859C-79851DE6F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98431-ED8B-8345-9CDE-7F339212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B919F9-9767-2C4C-A436-09368FA5B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910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D655C4-8B35-F44A-ABAE-9BCA499C13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DF20D9-E4B0-4442-AF73-F04DEE2D9A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80D9B-B7AE-1C49-8F14-6973407D3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64840-835E-4544-A6E7-70B0D3C43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B4B05-FD78-B844-917C-54D24BD0A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605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15581-D8E6-A142-82F3-0D0CAA657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55FF1A-F4A8-1C48-9740-0BA027FDA4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DD3C9-3D1A-D144-B22F-CA121AAF3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B7CB2A-A58A-894A-8F3B-7E445DAB5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290C6-B79C-6444-B423-2B75B29BA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291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07C6DF-6C43-754F-8C3F-D9BE1750D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898449-DA9F-4547-99B7-843C845F5E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5E549-5871-3E4D-A483-D81B6B4CF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5058ED-0E4F-934B-94C4-F9A86073A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273EB-2434-624C-A0BF-2D474B899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49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1EA196-2528-0D4F-99A9-754EF4C7F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1F5F1F-4896-5B46-8BA7-6F40E67F4D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58AA1A-6234-734C-B471-6259FFFA1C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817CB-CC6C-C244-B59D-FCBE70EB9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3AB16D-65AA-C844-A966-DEDDC97EE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45E13B-34A1-1244-9467-34BA9915E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849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50918-310E-3547-BEB6-E9A20DDC0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0B4D8F-3D8D-3C42-8DCF-2839BCB2F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52551E-36E8-E345-AA1E-5C4FB2F992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9792EB-CA9C-A044-BF49-653D7AA7D2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5E13D5-56D7-1C4C-A390-1A48309958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C70C75-EF72-864A-AB53-60F9F8CAF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2F5A26-5441-DB4E-A301-C9BA1A09E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10EC45-B4C4-084C-9242-7AAC8E128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639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C928DB-A4F3-6845-9F54-1249E17F6A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A4E119-C565-BC47-9C23-C90656B58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2A1582-167B-A04F-B082-6361BC1B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3E918D-8D29-5945-A0F8-B2BC62C74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760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672411-00BA-E144-B8BC-334084D47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1B835D-05BF-5941-8102-9F147A93E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A8FC30-888D-FC4C-AD72-C30D0D065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887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BC873-99E0-E74A-ADA9-DAF7FB1E9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726D8B-FFA0-0D46-B80D-6FB2FEEB71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EC84EA-A48D-9646-B9B0-B419760AAF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7D50E2-6943-D34A-A9E1-17357BAF9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70EAC0-D084-BA44-A725-991276FDF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0D2C55-5FC9-1544-9BF4-29DB543BE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690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8F20A6-A77A-D240-8E5D-28319478CE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48B3C0-21EE-B34F-B821-EE47B8F7D3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97ECB-2401-B34E-94DA-211D133199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F26123-30D1-0049-B6C5-1A4258BEB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BD6F44-0D7C-934D-9568-9DC16A115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4EB5BE-E513-4649-BCCD-6DBC623FE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233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C57C26-B0AA-6547-A382-3CE43979D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9EC96D-0AC4-E64B-8C87-0397184D2F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7B39B5-980F-ED45-906A-D06B87EBD9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127B3-74C3-EC44-984C-EF1B2B57A9A5}" type="datetimeFigureOut">
              <a:rPr lang="en-US" smtClean="0"/>
              <a:t>3/1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1880A-143F-FB4C-88BA-F15F310CDF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7A5B86-BF7C-1B49-B43F-E560297BF8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A6804-3751-BA48-8F94-59D6F802A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513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5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8C650BB5-5CF3-7940-BDC4-CF7086E75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266479" y="955363"/>
            <a:ext cx="3703320" cy="736282"/>
          </a:xfrm>
          <a:solidFill>
            <a:schemeClr val="tx1"/>
          </a:solidFill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>
            <a:normAutofit fontScale="92500" lnSpcReduction="20000"/>
          </a:bodyPr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P21 Female</a:t>
            </a:r>
          </a:p>
          <a:p>
            <a:pPr algn="ctr"/>
            <a:r>
              <a:rPr lang="en-US" i="1" dirty="0">
                <a:solidFill>
                  <a:schemeClr val="bg1"/>
                </a:solidFill>
              </a:rPr>
              <a:t>Tor1a</a:t>
            </a:r>
            <a:r>
              <a:rPr lang="en-US" baseline="30000" dirty="0">
                <a:solidFill>
                  <a:schemeClr val="bg1"/>
                </a:solidFill>
              </a:rPr>
              <a:t>+/+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C8367BEB-7480-0242-AF83-A866CE84B3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623870" y="955363"/>
            <a:ext cx="3703320" cy="736282"/>
          </a:xfrm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  <p:txBody>
          <a:bodyPr>
            <a:normAutofit fontScale="92500" lnSpcReduction="20000"/>
          </a:bodyPr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P21 Female</a:t>
            </a:r>
          </a:p>
          <a:p>
            <a:pPr algn="ctr"/>
            <a:r>
              <a:rPr lang="en-US" i="1" dirty="0">
                <a:solidFill>
                  <a:schemeClr val="bg1"/>
                </a:solidFill>
              </a:rPr>
              <a:t>Tor1a</a:t>
            </a:r>
            <a:r>
              <a:rPr lang="en-US" baseline="30000" dirty="0">
                <a:solidFill>
                  <a:schemeClr val="bg1"/>
                </a:solidFill>
              </a:rPr>
              <a:t>+/</a:t>
            </a:r>
            <a:r>
              <a:rPr lang="en-US" baseline="30000" dirty="0" err="1">
                <a:solidFill>
                  <a:schemeClr val="bg1"/>
                </a:solidFill>
                <a:latin typeface="Symbol" pitchFamily="2" charset="2"/>
              </a:rPr>
              <a:t>D</a:t>
            </a:r>
            <a:r>
              <a:rPr lang="en-US" baseline="30000" dirty="0" err="1">
                <a:solidFill>
                  <a:schemeClr val="bg1"/>
                </a:solidFill>
              </a:rPr>
              <a:t>gag</a:t>
            </a:r>
            <a:endParaRPr lang="en-US" baseline="30000" dirty="0">
              <a:solidFill>
                <a:schemeClr val="bg1"/>
              </a:solidFill>
            </a:endParaRPr>
          </a:p>
        </p:txBody>
      </p:sp>
      <p:pic>
        <p:nvPicPr>
          <p:cNvPr id="19" name="Wildtype DE458D VID_20190605_151659 2.mp4">
            <a:hlinkClick r:id="" action="ppaction://media"/>
            <a:extLst>
              <a:ext uri="{FF2B5EF4-FFF2-40B4-BE49-F238E27FC236}">
                <a16:creationId xmlns:a16="http://schemas.microsoft.com/office/drawing/2014/main" id="{AAA53DF9-22EB-DF4A-AE09-F8E05FBE99D1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82633" y="1869763"/>
            <a:ext cx="5671012" cy="3190709"/>
          </a:xfrm>
        </p:spPr>
      </p:pic>
      <p:pic>
        <p:nvPicPr>
          <p:cNvPr id="29" name="DE+ DE482A VID_20190611_112121.mp4">
            <a:hlinkClick r:id="" action="ppaction://media"/>
            <a:extLst>
              <a:ext uri="{FF2B5EF4-FFF2-40B4-BE49-F238E27FC236}">
                <a16:creationId xmlns:a16="http://schemas.microsoft.com/office/drawing/2014/main" id="{04B88B9F-464A-3747-AD3A-FC0DFF32360B}"/>
              </a:ext>
            </a:extLst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286152" y="1854053"/>
            <a:ext cx="5698941" cy="3206419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B8280E-E914-CB44-B6D7-BB5B2A2AE7D4}"/>
              </a:ext>
            </a:extLst>
          </p:cNvPr>
          <p:cNvSpPr txBox="1"/>
          <p:nvPr/>
        </p:nvSpPr>
        <p:spPr>
          <a:xfrm>
            <a:off x="9357579" y="6001788"/>
            <a:ext cx="2627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scalho, </a:t>
            </a:r>
            <a:r>
              <a:rPr lang="en-US" i="1" dirty="0"/>
              <a:t>et al.</a:t>
            </a:r>
          </a:p>
          <a:p>
            <a:r>
              <a:rPr lang="en-US" dirty="0"/>
              <a:t>Supplemental Video 1 &amp; 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BE61CE1-6525-3C4D-A1BE-E3DDA453B794}"/>
              </a:ext>
            </a:extLst>
          </p:cNvPr>
          <p:cNvSpPr/>
          <p:nvPr/>
        </p:nvSpPr>
        <p:spPr>
          <a:xfrm>
            <a:off x="282633" y="5060472"/>
            <a:ext cx="22476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Video 1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3FEDBD4-9C9D-DC44-AAC4-B664337CE60A}"/>
              </a:ext>
            </a:extLst>
          </p:cNvPr>
          <p:cNvSpPr/>
          <p:nvPr/>
        </p:nvSpPr>
        <p:spPr>
          <a:xfrm>
            <a:off x="6286152" y="5038214"/>
            <a:ext cx="22476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Video 2</a:t>
            </a:r>
          </a:p>
        </p:txBody>
      </p:sp>
    </p:spTree>
    <p:extLst>
      <p:ext uri="{BB962C8B-B14F-4D97-AF65-F5344CB8AC3E}">
        <p14:creationId xmlns:p14="http://schemas.microsoft.com/office/powerpoint/2010/main" val="2080284426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seq concurrent="1" nextAc="seek">
              <p:cTn id="3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" fill="hold">
                      <p:stCondLst>
                        <p:cond delay="0"/>
                      </p:stCondLst>
                      <p:childTnLst>
                        <p:par>
                          <p:cTn id="5" fill="hold">
                            <p:stCondLst>
                              <p:cond delay="0"/>
                            </p:stCondLst>
                            <p:childTnLst>
                              <p:par>
                                <p:cTn id="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29"/>
                </p:tgtEl>
              </p:cMediaNode>
            </p:video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2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" dur="1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9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5</Words>
  <Application>Microsoft Macintosh PowerPoint</Application>
  <PresentationFormat>Widescreen</PresentationFormat>
  <Paragraphs>8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e</dc:creator>
  <cp:lastModifiedBy>Rose</cp:lastModifiedBy>
  <cp:revision>2</cp:revision>
  <dcterms:created xsi:type="dcterms:W3CDTF">2020-03-16T13:26:39Z</dcterms:created>
  <dcterms:modified xsi:type="dcterms:W3CDTF">2020-03-18T16:30:16Z</dcterms:modified>
</cp:coreProperties>
</file>